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39" autoAdjust="0"/>
  </p:normalViewPr>
  <p:slideViewPr>
    <p:cSldViewPr>
      <p:cViewPr>
        <p:scale>
          <a:sx n="160" d="100"/>
          <a:sy n="160" d="100"/>
        </p:scale>
        <p:origin x="-1074" y="52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3B987-3507-4060-ACC5-C5386FEA543E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5C391-60A4-4F25-9986-5249D95A3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750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3B987-3507-4060-ACC5-C5386FEA543E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5C391-60A4-4F25-9986-5249D95A3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343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3B987-3507-4060-ACC5-C5386FEA543E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5C391-60A4-4F25-9986-5249D95A3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198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3B987-3507-4060-ACC5-C5386FEA543E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5C391-60A4-4F25-9986-5249D95A3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710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3B987-3507-4060-ACC5-C5386FEA543E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5C391-60A4-4F25-9986-5249D95A3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928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3B987-3507-4060-ACC5-C5386FEA543E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5C391-60A4-4F25-9986-5249D95A3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0386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3B987-3507-4060-ACC5-C5386FEA543E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5C391-60A4-4F25-9986-5249D95A3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7585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3B987-3507-4060-ACC5-C5386FEA543E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5C391-60A4-4F25-9986-5249D95A3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463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3B987-3507-4060-ACC5-C5386FEA543E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5C391-60A4-4F25-9986-5249D95A3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484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3B987-3507-4060-ACC5-C5386FEA543E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5C391-60A4-4F25-9986-5249D95A3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102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3B987-3507-4060-ACC5-C5386FEA543E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5C391-60A4-4F25-9986-5249D95A3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948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B3B987-3507-4060-ACC5-C5386FEA543E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D5C391-60A4-4F25-9986-5249D95A3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839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681990" y="392689"/>
            <a:ext cx="609600" cy="3048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 smtClean="0">
                <a:solidFill>
                  <a:schemeClr val="tx1"/>
                </a:solidFill>
              </a:rPr>
              <a:t>A</a:t>
            </a:r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4366404" y="402940"/>
            <a:ext cx="609600" cy="3048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B</a:t>
            </a:r>
          </a:p>
        </p:txBody>
      </p:sp>
      <p:sp>
        <p:nvSpPr>
          <p:cNvPr id="12" name="Rectangle 11"/>
          <p:cNvSpPr/>
          <p:nvPr/>
        </p:nvSpPr>
        <p:spPr>
          <a:xfrm>
            <a:off x="1291590" y="4648200"/>
            <a:ext cx="282321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BMC t60 replicate 1  (raw </a:t>
            </a:r>
            <a:r>
              <a:rPr lang="en-US" sz="8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NA count</a:t>
            </a:r>
            <a:r>
              <a:rPr lang="en-US" sz="8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/>
          <p:cNvSpPr/>
          <p:nvPr/>
        </p:nvSpPr>
        <p:spPr>
          <a:xfrm rot="16200000">
            <a:off x="3271888" y="2497347"/>
            <a:ext cx="2853905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b="1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. coli </a:t>
            </a:r>
            <a:r>
              <a:rPr lang="en-US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120 replicate </a:t>
            </a:r>
            <a:r>
              <a:rPr lang="en-US" sz="8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 (</a:t>
            </a:r>
            <a:r>
              <a:rPr lang="en-US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w  </a:t>
            </a:r>
            <a:r>
              <a:rPr lang="en-US" sz="8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NA count)</a:t>
            </a:r>
            <a:endParaRPr lang="en-US" sz="8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/>
          <p:cNvSpPr/>
          <p:nvPr/>
        </p:nvSpPr>
        <p:spPr>
          <a:xfrm rot="16200000">
            <a:off x="-1184101" y="2383048"/>
            <a:ext cx="2625307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BMC t60 </a:t>
            </a:r>
            <a:r>
              <a:rPr lang="en-US" sz="8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licate 2 (raw  miRNA count)</a:t>
            </a:r>
            <a:endParaRPr lang="en-US" sz="8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5441868" y="4699240"/>
            <a:ext cx="2823210" cy="2286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i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. </a:t>
            </a:r>
            <a:r>
              <a:rPr lang="en-US" sz="800" b="1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800" b="1" i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li </a:t>
            </a:r>
            <a:r>
              <a:rPr lang="en-US" sz="8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120 replicate 1 (raw </a:t>
            </a:r>
            <a:r>
              <a:rPr lang="en-US" sz="8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NA count</a:t>
            </a:r>
            <a:r>
              <a:rPr lang="en-US" sz="8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161808" y="4421743"/>
            <a:ext cx="37535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50000                 100000              150000              200000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3070693" y="2325527"/>
            <a:ext cx="36626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10000               20000        30000             40000      50000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5014" y="968474"/>
            <a:ext cx="4102269" cy="3389096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612812" y="4406126"/>
            <a:ext cx="37535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e+00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e+05 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2e+05             3e+05             4e+05             5e+0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-1373406" y="2381932"/>
            <a:ext cx="36626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0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10000               20000        30000             40000      50000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354" y="966066"/>
            <a:ext cx="3998646" cy="33769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60870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</TotalTime>
  <Words>67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avy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er, Regina CTR NMRC</dc:creator>
  <cp:lastModifiedBy>Cer, Regina CTR NMRC</cp:lastModifiedBy>
  <cp:revision>14</cp:revision>
  <dcterms:created xsi:type="dcterms:W3CDTF">2017-06-12T20:35:03Z</dcterms:created>
  <dcterms:modified xsi:type="dcterms:W3CDTF">2017-06-20T16:00:26Z</dcterms:modified>
</cp:coreProperties>
</file>